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34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สไลด์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BD579DE7-7546-6D9C-3558-7D35857CAC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ชื่อเรื่องรอง 2">
            <a:extLst>
              <a:ext uri="{FF2B5EF4-FFF2-40B4-BE49-F238E27FC236}">
                <a16:creationId xmlns:a16="http://schemas.microsoft.com/office/drawing/2014/main" id="{65F74F2F-BFC2-8C44-86E5-C34867A52D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h-TH"/>
              <a:t>คลิกเพื่อแก้ไขสไตล์ชื่อเรื่องรอง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5C6E3813-0CAC-0BB4-F4BC-AF7A1D26CD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AA864-41B2-45DC-B37E-6671CDEB21E3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7E6A52F2-C54B-C4A6-53CD-2DCBC2082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439939DF-C16B-8ED3-C73F-55CCFA07C7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CAEAC0-F596-4B5E-B577-284A66A1EF5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896436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ชื่อเรื่องและข้อความ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9FC6D613-F3FD-A393-1609-A68FB7C485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6E8F3F9D-CB93-7262-CD4D-77CD5AF786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F91B7CFA-59D7-EDB2-FFB2-0EE2C9FAB3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AA864-41B2-45DC-B37E-6671CDEB21E3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119B0B01-8ED8-0D96-BA05-7536E7F9D5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0C2E3D3D-608F-260F-C9B8-9C650A5CC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CAEAC0-F596-4B5E-B577-284A66A1EF5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823029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ข้อความและชื่อเรื่อง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แนวตั้ง 1">
            <a:extLst>
              <a:ext uri="{FF2B5EF4-FFF2-40B4-BE49-F238E27FC236}">
                <a16:creationId xmlns:a16="http://schemas.microsoft.com/office/drawing/2014/main" id="{85BD6ACB-8BAC-6BD5-B597-A3D8CD3D2F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6FAC3EBC-A37F-CC20-57CD-A3D2498995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28784705-BC78-0C2A-0FC4-2F5C9C19C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AA864-41B2-45DC-B37E-6671CDEB21E3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122D89D3-0826-C42E-E363-B4C184D5E8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5004F292-294A-B547-3513-C18BE008F9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CAEAC0-F596-4B5E-B577-284A66A1EF5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941715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ชื่อเรื่องและเนื้อห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15525594-EF01-6C92-98DA-4F99D341D4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DE536D4A-0563-A9B2-C3E2-FA3B04F449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2E9DF975-AEED-3965-E26E-938D93A7CF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AA864-41B2-45DC-B37E-6671CDEB21E3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BC29A485-3005-40C9-F5F8-C2A2F056F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2531FD3E-EB16-655E-7C57-2C3CAD07D4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CAEAC0-F596-4B5E-B577-284A66A1EF5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978636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ส่วนหัวของ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08AFB222-F873-7E70-291C-8A3B55FFDB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DFD5D70F-2F90-A2F6-155F-F026A81B89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94B35F42-D8D9-BC53-C414-52FC256DAF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AA864-41B2-45DC-B37E-6671CDEB21E3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C1CA475C-E18D-0FBE-E3A9-24754E3EF3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D4B6E698-7168-C739-7CC4-E35A11A30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CAEAC0-F596-4B5E-B577-284A66A1EF5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131100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เนื้อหา 2 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5C6BFCA5-711B-C2EA-F059-45E037BE23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802D28F2-2F30-5278-3562-F04EBB116E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6ABF3D48-DBA1-7259-B8E6-DBF0BC0DB6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39C5B980-E7FB-46F5-1498-EF4CF5C88E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AA864-41B2-45DC-B37E-6671CDEB21E3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20CFEC24-E5F4-2D03-B263-846C44F2C7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31959BBC-8F22-B959-5BF8-0DEEAA4B1F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CAEAC0-F596-4B5E-B577-284A66A1EF5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055484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การเปรียบเทียบ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C110DB84-B246-2C4E-4D8F-680DFB4816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48B8986C-5372-9C86-0177-5842EE6D4F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F045B0EA-E13D-FA2F-56B7-7C4D6FFD17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ข้อความ 4">
            <a:extLst>
              <a:ext uri="{FF2B5EF4-FFF2-40B4-BE49-F238E27FC236}">
                <a16:creationId xmlns:a16="http://schemas.microsoft.com/office/drawing/2014/main" id="{428519F2-5A07-809A-0C9F-AF50F94C75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6" name="ตัวแทนเนื้อหา 5">
            <a:extLst>
              <a:ext uri="{FF2B5EF4-FFF2-40B4-BE49-F238E27FC236}">
                <a16:creationId xmlns:a16="http://schemas.microsoft.com/office/drawing/2014/main" id="{9C3ECC82-D84F-F50D-C569-85F54BDD76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7" name="ตัวแทนวันที่ 6">
            <a:extLst>
              <a:ext uri="{FF2B5EF4-FFF2-40B4-BE49-F238E27FC236}">
                <a16:creationId xmlns:a16="http://schemas.microsoft.com/office/drawing/2014/main" id="{CE7FA283-661D-9A15-1782-02F2B77A75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AA864-41B2-45DC-B37E-6671CDEB21E3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8" name="ตัวแทนท้ายกระดาษ 7">
            <a:extLst>
              <a:ext uri="{FF2B5EF4-FFF2-40B4-BE49-F238E27FC236}">
                <a16:creationId xmlns:a16="http://schemas.microsoft.com/office/drawing/2014/main" id="{09C9A037-32DD-C637-17C2-EC71C85B5A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ตัวแทนหมายเลขสไลด์ 8">
            <a:extLst>
              <a:ext uri="{FF2B5EF4-FFF2-40B4-BE49-F238E27FC236}">
                <a16:creationId xmlns:a16="http://schemas.microsoft.com/office/drawing/2014/main" id="{07486CA5-07BD-03B4-219A-A7650EC495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CAEAC0-F596-4B5E-B577-284A66A1EF5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5488605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เฉพาะ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D4341639-692B-3C21-B7ED-585828C03C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วันที่ 2">
            <a:extLst>
              <a:ext uri="{FF2B5EF4-FFF2-40B4-BE49-F238E27FC236}">
                <a16:creationId xmlns:a16="http://schemas.microsoft.com/office/drawing/2014/main" id="{FC2E0EB9-BB23-A3B5-C3E4-E2597F281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AA864-41B2-45DC-B37E-6671CDEB21E3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4" name="ตัวแทนท้ายกระดาษ 3">
            <a:extLst>
              <a:ext uri="{FF2B5EF4-FFF2-40B4-BE49-F238E27FC236}">
                <a16:creationId xmlns:a16="http://schemas.microsoft.com/office/drawing/2014/main" id="{FF6B01E2-CA01-E66D-D5E6-36AC4626E7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ตัวแทนหมายเลขสไลด์ 4">
            <a:extLst>
              <a:ext uri="{FF2B5EF4-FFF2-40B4-BE49-F238E27FC236}">
                <a16:creationId xmlns:a16="http://schemas.microsoft.com/office/drawing/2014/main" id="{BA40C93A-0D2F-29C2-2E8F-BB33295CD6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CAEAC0-F596-4B5E-B577-284A66A1EF5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306752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ว่างเปล่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วันที่ 1">
            <a:extLst>
              <a:ext uri="{FF2B5EF4-FFF2-40B4-BE49-F238E27FC236}">
                <a16:creationId xmlns:a16="http://schemas.microsoft.com/office/drawing/2014/main" id="{D2880AE5-0E09-2F43-16FD-910827C17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AA864-41B2-45DC-B37E-6671CDEB21E3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3" name="ตัวแทนท้ายกระดาษ 2">
            <a:extLst>
              <a:ext uri="{FF2B5EF4-FFF2-40B4-BE49-F238E27FC236}">
                <a16:creationId xmlns:a16="http://schemas.microsoft.com/office/drawing/2014/main" id="{3C5224FE-71B8-8244-800B-EA779A0E41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ตัวแทนหมายเลขสไลด์ 3">
            <a:extLst>
              <a:ext uri="{FF2B5EF4-FFF2-40B4-BE49-F238E27FC236}">
                <a16:creationId xmlns:a16="http://schemas.microsoft.com/office/drawing/2014/main" id="{7A8D13B5-D95B-9982-3915-C62F7BCFDA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CAEAC0-F596-4B5E-B577-284A66A1EF5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579746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เนื้อหา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95902C21-0407-A7C6-6DA3-11CBC9D29E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CC68D37E-88F9-EE2A-32D3-87C99CD5C9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67FA9863-BEE6-9236-4242-C64D9AB08B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C3658FFD-0067-7695-2958-EDDBF89B68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AA864-41B2-45DC-B37E-6671CDEB21E3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67CA6A05-05A7-9194-A9C9-BEF70CB309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03DF7959-46A1-B7CD-7026-1674786E2F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CAEAC0-F596-4B5E-B577-284A66A1EF5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9028880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รูปภาพ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C38BE995-D81F-9479-1B6B-04CD10E286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รูปภาพ 2">
            <a:extLst>
              <a:ext uri="{FF2B5EF4-FFF2-40B4-BE49-F238E27FC236}">
                <a16:creationId xmlns:a16="http://schemas.microsoft.com/office/drawing/2014/main" id="{21FC842E-75CC-74ED-5236-856CA57DC5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7983CD4C-EB3E-1AB3-3CBE-223182E64F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8CF67233-7136-86DD-B88B-8617F8DA52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AA864-41B2-45DC-B37E-6671CDEB21E3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9C3DD58A-F45A-C316-3FF7-1D2EB39BCA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37116AF6-C432-6DFA-AFF5-0016EEDD2D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CAEAC0-F596-4B5E-B577-284A66A1EF5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605296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ชื่อเรื่อง 1">
            <a:extLst>
              <a:ext uri="{FF2B5EF4-FFF2-40B4-BE49-F238E27FC236}">
                <a16:creationId xmlns:a16="http://schemas.microsoft.com/office/drawing/2014/main" id="{56FFCBA9-186C-02FD-3869-83C2395B2E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E8092F1D-D4B5-C168-2E63-A803A2F193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6BAFBA5C-92E8-0630-2F19-C3BEBED0536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DAA864-41B2-45DC-B37E-6671CDEB21E3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D88D1F66-4E12-AFDD-37FE-6E647D704E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0B777FF4-45D6-0777-7C15-5A2D09D778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CAEAC0-F596-4B5E-B577-284A66A1EF5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336010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รูปภาพ 1">
            <a:extLst>
              <a:ext uri="{FF2B5EF4-FFF2-40B4-BE49-F238E27FC236}">
                <a16:creationId xmlns:a16="http://schemas.microsoft.com/office/drawing/2014/main" id="{A5DB61FD-FE87-9523-3BAC-7C5DDE1E81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3536" y="2080174"/>
            <a:ext cx="8888322" cy="2051879"/>
          </a:xfrm>
          <a:prstGeom prst="rect">
            <a:avLst/>
          </a:prstGeom>
        </p:spPr>
      </p:pic>
      <p:sp>
        <p:nvSpPr>
          <p:cNvPr id="4" name="กล่องข้อความ 3">
            <a:extLst>
              <a:ext uri="{FF2B5EF4-FFF2-40B4-BE49-F238E27FC236}">
                <a16:creationId xmlns:a16="http://schemas.microsoft.com/office/drawing/2014/main" id="{FF8A2AD7-10D1-9394-B79F-1C39632B3C48}"/>
              </a:ext>
            </a:extLst>
          </p:cNvPr>
          <p:cNvSpPr txBox="1"/>
          <p:nvPr/>
        </p:nvSpPr>
        <p:spPr>
          <a:xfrm>
            <a:off x="1779557" y="4219506"/>
            <a:ext cx="8632885" cy="4778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upplementary Figure S4: Chromatogram in - ESI scan mode of the 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Clerodendrum </a:t>
            </a:r>
            <a:r>
              <a:rPr lang="en-US" sz="1200" b="1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erratum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 (Linn.) Moon (CSM) drying with dehydration chamber, showing the major retention times of detected compound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2701560342"/>
      </p:ext>
    </p:extLst>
  </p:cSld>
  <p:clrMapOvr>
    <a:masterClrMapping/>
  </p:clrMapOvr>
</p:sld>
</file>

<file path=ppt/theme/theme1.xml><?xml version="1.0" encoding="utf-8"?>
<a:theme xmlns:a="http://schemas.openxmlformats.org/drawingml/2006/main" name="ธีมของ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5</Words>
  <Application>Microsoft Office PowerPoint</Application>
  <PresentationFormat>แบบจอกว้าง</PresentationFormat>
  <Paragraphs>1</Paragraphs>
  <Slides>1</Slides>
  <Notes>0</Notes>
  <HiddenSlides>0</HiddenSlides>
  <MMClips>0</MMClips>
  <ScaleCrop>false</ScaleCrop>
  <HeadingPairs>
    <vt:vector size="6" baseType="variant">
      <vt:variant>
        <vt:lpstr>ฟอนต์ที่ถูกใช้</vt:lpstr>
      </vt:variant>
      <vt:variant>
        <vt:i4>4</vt:i4>
      </vt:variant>
      <vt:variant>
        <vt:lpstr>ธีม</vt:lpstr>
      </vt:variant>
      <vt:variant>
        <vt:i4>1</vt:i4>
      </vt:variant>
      <vt:variant>
        <vt:lpstr>ชื่อเรื่องสไลด์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ธีมของ Office</vt:lpstr>
      <vt:lpstr>งานนำเสนอ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กิ่งกาญจน์ บรรลือพืช</dc:creator>
  <cp:lastModifiedBy>กิ่งกาญจน์ บรรลือพืช</cp:lastModifiedBy>
  <cp:revision>1</cp:revision>
  <dcterms:created xsi:type="dcterms:W3CDTF">2026-02-22T09:04:20Z</dcterms:created>
  <dcterms:modified xsi:type="dcterms:W3CDTF">2026-02-22T09:05:25Z</dcterms:modified>
</cp:coreProperties>
</file>